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56" r:id="rId3"/>
    <p:sldId id="257" r:id="rId4"/>
    <p:sldId id="258" r:id="rId5"/>
    <p:sldId id="259" r:id="rId6"/>
    <p:sldId id="260" r:id="rId7"/>
    <p:sldId id="261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>
        <p:scale>
          <a:sx n="115" d="100"/>
          <a:sy n="115" d="100"/>
        </p:scale>
        <p:origin x="2019" y="-124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17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0529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238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709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3302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736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706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4334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1243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28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3550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F57C9-B99A-4BB6-8FB6-28DC6B85240D}" type="datetimeFigureOut">
              <a:rPr lang="fr-FR" smtClean="0"/>
              <a:t>16/0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B9EA9-FA5B-4BD1-A494-472AB21E10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4242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3056" y="3162749"/>
            <a:ext cx="1020575" cy="1034533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42" t="9718"/>
          <a:stretch/>
        </p:blipFill>
        <p:spPr>
          <a:xfrm>
            <a:off x="2377844" y="1041568"/>
            <a:ext cx="1005787" cy="1032704"/>
          </a:xfrm>
          <a:prstGeom prst="rect">
            <a:avLst/>
          </a:prstGeom>
        </p:spPr>
      </p:pic>
      <p:sp>
        <p:nvSpPr>
          <p:cNvPr id="4" name="Rectangle 29"/>
          <p:cNvSpPr>
            <a:spLocks noChangeArrowheads="1"/>
          </p:cNvSpPr>
          <p:nvPr/>
        </p:nvSpPr>
        <p:spPr bwMode="auto">
          <a:xfrm>
            <a:off x="1" y="1861751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35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5" name="ZoneTexte 20"/>
          <p:cNvSpPr txBox="1">
            <a:spLocks noChangeArrowheads="1"/>
          </p:cNvSpPr>
          <p:nvPr/>
        </p:nvSpPr>
        <p:spPr bwMode="auto">
          <a:xfrm>
            <a:off x="3151933" y="8161278"/>
            <a:ext cx="295793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E</a:t>
            </a:r>
            <a:endParaRPr kumimoji="0" lang="fr-FR" alt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36" name="ZoneTexte 21"/>
          <p:cNvSpPr txBox="1">
            <a:spLocks noChangeArrowheads="1"/>
          </p:cNvSpPr>
          <p:nvPr/>
        </p:nvSpPr>
        <p:spPr bwMode="auto">
          <a:xfrm>
            <a:off x="5139275" y="8197218"/>
            <a:ext cx="304481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F</a:t>
            </a:r>
            <a:endParaRPr kumimoji="0" lang="fr-FR" alt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37" name="ZoneTexte 26"/>
          <p:cNvSpPr txBox="1">
            <a:spLocks noChangeArrowheads="1"/>
          </p:cNvSpPr>
          <p:nvPr/>
        </p:nvSpPr>
        <p:spPr bwMode="auto">
          <a:xfrm>
            <a:off x="2554115" y="786656"/>
            <a:ext cx="970383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WT+GCV</a:t>
            </a:r>
            <a:endParaRPr kumimoji="0" lang="fr-FR" alt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38" name="ZoneTexte 28"/>
          <p:cNvSpPr txBox="1">
            <a:spLocks noChangeArrowheads="1"/>
          </p:cNvSpPr>
          <p:nvPr/>
        </p:nvSpPr>
        <p:spPr bwMode="auto">
          <a:xfrm>
            <a:off x="3436827" y="784588"/>
            <a:ext cx="1012649" cy="397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   Tg </a:t>
            </a:r>
            <a:r>
              <a:rPr kumimoji="0" lang="fr-FR" altLang="fr-FR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Ctr</a:t>
            </a:r>
            <a:endParaRPr kumimoji="0" lang="fr-FR" alt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940" t="13375" r="10650"/>
          <a:stretch/>
        </p:blipFill>
        <p:spPr>
          <a:xfrm>
            <a:off x="2351977" y="2127188"/>
            <a:ext cx="1031654" cy="978935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97" t="15231"/>
          <a:stretch/>
        </p:blipFill>
        <p:spPr>
          <a:xfrm>
            <a:off x="3434774" y="2130268"/>
            <a:ext cx="1025403" cy="984479"/>
          </a:xfrm>
          <a:prstGeom prst="rect">
            <a:avLst/>
          </a:prstGeom>
        </p:spPr>
      </p:pic>
      <p:cxnSp>
        <p:nvCxnSpPr>
          <p:cNvPr id="14" name="Connecteur droit 13"/>
          <p:cNvCxnSpPr/>
          <p:nvPr/>
        </p:nvCxnSpPr>
        <p:spPr>
          <a:xfrm>
            <a:off x="2454567" y="2010697"/>
            <a:ext cx="9113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2459592" y="3023963"/>
            <a:ext cx="1002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2429911" y="4130206"/>
            <a:ext cx="1002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6"/>
          <p:cNvSpPr txBox="1">
            <a:spLocks noChangeArrowheads="1"/>
          </p:cNvSpPr>
          <p:nvPr/>
        </p:nvSpPr>
        <p:spPr bwMode="auto">
          <a:xfrm>
            <a:off x="2821341" y="1045733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GFAP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25" name="ZoneTexte 26"/>
          <p:cNvSpPr txBox="1">
            <a:spLocks noChangeArrowheads="1"/>
          </p:cNvSpPr>
          <p:nvPr/>
        </p:nvSpPr>
        <p:spPr bwMode="auto">
          <a:xfrm>
            <a:off x="2714586" y="2106326"/>
            <a:ext cx="72874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CC00CC"/>
                </a:solidFill>
                <a:effectLst/>
                <a:uLnTx/>
                <a:uFillTx/>
                <a:latin typeface="Ubuntu"/>
                <a:ea typeface="+mn-ea"/>
                <a:cs typeface="+mn-cs"/>
              </a:rPr>
              <a:t>Vimentin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srgbClr val="CC00CC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26" name="ZoneTexte 26"/>
          <p:cNvSpPr txBox="1">
            <a:spLocks noChangeArrowheads="1"/>
          </p:cNvSpPr>
          <p:nvPr/>
        </p:nvSpPr>
        <p:spPr bwMode="auto">
          <a:xfrm>
            <a:off x="2715468" y="3165786"/>
            <a:ext cx="72874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+mn-ea"/>
                <a:cs typeface="+mn-cs"/>
              </a:rPr>
              <a:t>Sox2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27" name="ZoneTexte 26"/>
          <p:cNvSpPr txBox="1">
            <a:spLocks noChangeArrowheads="1"/>
          </p:cNvSpPr>
          <p:nvPr/>
        </p:nvSpPr>
        <p:spPr bwMode="auto">
          <a:xfrm>
            <a:off x="2242808" y="1014773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A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29" name="ZoneTexte 28"/>
          <p:cNvSpPr txBox="1">
            <a:spLocks noChangeArrowheads="1"/>
          </p:cNvSpPr>
          <p:nvPr/>
        </p:nvSpPr>
        <p:spPr bwMode="auto">
          <a:xfrm>
            <a:off x="2191847" y="2092969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C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30" name="ZoneTexte 29"/>
          <p:cNvSpPr txBox="1">
            <a:spLocks noChangeArrowheads="1"/>
          </p:cNvSpPr>
          <p:nvPr/>
        </p:nvSpPr>
        <p:spPr bwMode="auto">
          <a:xfrm>
            <a:off x="2191847" y="3122258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E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31" name="ZoneTexte 30"/>
          <p:cNvSpPr txBox="1">
            <a:spLocks noChangeArrowheads="1"/>
          </p:cNvSpPr>
          <p:nvPr/>
        </p:nvSpPr>
        <p:spPr bwMode="auto">
          <a:xfrm>
            <a:off x="3285396" y="2123965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D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579128" y="1088128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MH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2562706" y="2209803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MH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2361377" y="3250331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MH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2421873" y="1454111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2492398" y="2594345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2400958" y="3561596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2929126" y="1876310"/>
            <a:ext cx="3241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790247" y="2901623"/>
            <a:ext cx="3241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2737329" y="3991744"/>
            <a:ext cx="3241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</a:t>
            </a:r>
            <a:endParaRPr kumimoji="0" lang="fr-FR" sz="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774" y="1042319"/>
            <a:ext cx="1022500" cy="103477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774" y="3162749"/>
            <a:ext cx="1022500" cy="1032350"/>
          </a:xfrm>
          <a:prstGeom prst="rect">
            <a:avLst/>
          </a:prstGeom>
        </p:spPr>
      </p:pic>
      <p:sp>
        <p:nvSpPr>
          <p:cNvPr id="32" name="ZoneTexte 31"/>
          <p:cNvSpPr txBox="1">
            <a:spLocks noChangeArrowheads="1"/>
          </p:cNvSpPr>
          <p:nvPr/>
        </p:nvSpPr>
        <p:spPr bwMode="auto">
          <a:xfrm>
            <a:off x="3254567" y="3140342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F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28" name="ZoneTexte 27"/>
          <p:cNvSpPr txBox="1">
            <a:spLocks noChangeArrowheads="1"/>
          </p:cNvSpPr>
          <p:nvPr/>
        </p:nvSpPr>
        <p:spPr bwMode="auto">
          <a:xfrm>
            <a:off x="3291744" y="1056401"/>
            <a:ext cx="614935" cy="33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altLang="fr-FR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Ubuntu"/>
                <a:ea typeface="Droid Sans Fallback" charset="0"/>
                <a:cs typeface="FreeSans" charset="0"/>
              </a:rPr>
              <a:t>B</a:t>
            </a:r>
            <a:endParaRPr kumimoji="0" lang="fr-FR" altLang="fr-FR" sz="1200" b="0" i="0" u="none" strike="noStrike" kern="1200" cap="none" spc="0" normalizeH="0" baseline="0" noProof="0" dirty="0" smtClean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955968" y="4518676"/>
            <a:ext cx="3402713" cy="8828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NSPCs markers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AP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, B),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C, D) and Sox2 (E, F)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BH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+GCV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C, E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, D, F)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le mice 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cale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rs, 50 µm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1854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089" y="1406768"/>
            <a:ext cx="6186403" cy="246631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13460" y="6048418"/>
            <a:ext cx="52992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al GCV administratio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es not affect food intake.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dy weight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food intake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recorded during treatment are not affect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+GC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le mice. Data are expressed as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≥5 for each group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The expressions of POMC (C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NPY (D) in the arcuate nucleus are not modified by the ablation of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FAP positive NSPC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ata are expressed as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ean±SE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n≥5 for each group. </a:t>
            </a:r>
            <a:endParaRPr lang="fr-FR" sz="12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752" y="4028195"/>
            <a:ext cx="5494763" cy="1807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8548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5650" y="969936"/>
            <a:ext cx="4372526" cy="3501855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388519" y="4723252"/>
            <a:ext cx="42405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analysis of the seminiferous tubules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rmatogoni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permatocytes per seminiferous tubule was assessed and expressed as the mean number of cells per mm² (n=3 tubules/image, 3 images/mouse and 2-3 mice/group)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re expressed as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*p&lt;0.01, ***p&lt;0.001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4622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144193" y="3694837"/>
            <a:ext cx="449785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transgenic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k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by RT-PCR. The total RNA from the testes and the striatum of thre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was analysed by RT-PCR. RT-PCR was performed as described in the Methods section either in the presence (+) or absence (−) of reverse transcriptase to control for DNA contamination. A PCR product of 495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k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detected in the striatum but not in the testes. A PCR product of 619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detected in both tissue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lyceraldehyde -3 -phosphate dehydrogenase;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k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ymidine kinase M, 1-kb marker; T, testes; S, striatum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6998" y="1388628"/>
            <a:ext cx="4951627" cy="2398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7314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54070" y="4152181"/>
            <a:ext cx="4664879" cy="14108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al GCV administratio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es not alter the cellula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ypt-villus architecture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tained cross sections of ileum and corresponding insets showing higher power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rophotographie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Ileum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+GC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exhibits a crypt-villus architecture indistinguishable from untreated WT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GCV-treated WT mice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howing no villi cellular abnormalities. Scale bars, 80 µm; Insets: 40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µm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356" y="1046889"/>
            <a:ext cx="4927287" cy="26869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60065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18938" y="6260539"/>
            <a:ext cx="385449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al GCV administratio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es not affect the expression of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sspeptin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E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sspeptin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belling (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mean number of E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ositive cells (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re not affected b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al GCV administration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expressed as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≥3 for each group.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9483" y="472188"/>
            <a:ext cx="4258954" cy="55079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0960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089499" y="4726197"/>
            <a:ext cx="490922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al GCV administration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es not affect the level of anxiety. </a:t>
            </a:r>
            <a:endParaRPr lang="en-GB" sz="1200" dirty="0" smtClean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s of entries (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the time spent (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each zone of the elevated plus maze are not affected b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 central GCV administration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h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marbles buried in a marble burying test is identical between the four experimental groups.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+GC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le mice display comparable plasma cortisol concentrations than the three control group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expressed as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≥3 for each group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6940" y="693795"/>
            <a:ext cx="5364120" cy="3878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5044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589</Words>
  <Application>Microsoft Office PowerPoint</Application>
  <PresentationFormat>Affichage à l'écran (4:3)</PresentationFormat>
  <Paragraphs>34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8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6" baseType="lpstr">
      <vt:lpstr>Arial</vt:lpstr>
      <vt:lpstr>Calibri</vt:lpstr>
      <vt:lpstr>Calibri Light</vt:lpstr>
      <vt:lpstr>Droid Sans Fallback</vt:lpstr>
      <vt:lpstr>FreeSans</vt:lpstr>
      <vt:lpstr>Symbol</vt:lpstr>
      <vt:lpstr>Times New Roman</vt:lpstr>
      <vt:lpstr>Ubuntu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tine Migaud</dc:creator>
  <cp:lastModifiedBy>Martine Migaud</cp:lastModifiedBy>
  <cp:revision>13</cp:revision>
  <dcterms:created xsi:type="dcterms:W3CDTF">2022-02-03T08:56:23Z</dcterms:created>
  <dcterms:modified xsi:type="dcterms:W3CDTF">2022-02-16T16:47:06Z</dcterms:modified>
</cp:coreProperties>
</file>